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7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엄 경현" userId="006d52b91ace3e0e" providerId="LiveId" clId="{7CBEC544-79C4-4312-853B-22BC8837977D}"/>
    <pc:docChg chg="modSld">
      <pc:chgData name="엄 경현" userId="006d52b91ace3e0e" providerId="LiveId" clId="{7CBEC544-79C4-4312-853B-22BC8837977D}" dt="2023-05-17T23:58:27.013" v="6" actId="1076"/>
      <pc:docMkLst>
        <pc:docMk/>
      </pc:docMkLst>
      <pc:sldChg chg="modSp mod">
        <pc:chgData name="엄 경현" userId="006d52b91ace3e0e" providerId="LiveId" clId="{7CBEC544-79C4-4312-853B-22BC8837977D}" dt="2023-05-17T23:58:27.013" v="6" actId="1076"/>
        <pc:sldMkLst>
          <pc:docMk/>
          <pc:sldMk cId="3235941439" sldId="281"/>
        </pc:sldMkLst>
        <pc:graphicFrameChg chg="mod modGraphic">
          <ac:chgData name="엄 경현" userId="006d52b91ace3e0e" providerId="LiveId" clId="{7CBEC544-79C4-4312-853B-22BC8837977D}" dt="2023-05-17T23:58:27.013" v="6" actId="1076"/>
          <ac:graphicFrameMkLst>
            <pc:docMk/>
            <pc:sldMk cId="3235941439" sldId="281"/>
            <ac:graphicFrameMk id="4" creationId="{7E83BB0F-0FB7-00FF-22DB-ECBDEE5FF6D5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515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7657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8385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4537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6643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732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2521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3552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7089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6174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8797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81842-706A-4304-A6A1-CA2194B2C6A8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0EE09-D4B7-4C70-9575-159EA9F976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796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7E83BB0F-0FB7-00FF-22DB-ECBDEE5FF6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8771660"/>
              </p:ext>
            </p:extLst>
          </p:nvPr>
        </p:nvGraphicFramePr>
        <p:xfrm>
          <a:off x="1109787" y="354376"/>
          <a:ext cx="6924425" cy="4394283"/>
        </p:xfrm>
        <a:graphic>
          <a:graphicData uri="http://schemas.openxmlformats.org/drawingml/2006/table">
            <a:tbl>
              <a:tblPr/>
              <a:tblGrid>
                <a:gridCol w="983986">
                  <a:extLst>
                    <a:ext uri="{9D8B030D-6E8A-4147-A177-3AD203B41FA5}">
                      <a16:colId xmlns:a16="http://schemas.microsoft.com/office/drawing/2014/main" val="3775594664"/>
                    </a:ext>
                  </a:extLst>
                </a:gridCol>
                <a:gridCol w="1602157">
                  <a:extLst>
                    <a:ext uri="{9D8B030D-6E8A-4147-A177-3AD203B41FA5}">
                      <a16:colId xmlns:a16="http://schemas.microsoft.com/office/drawing/2014/main" val="474686785"/>
                    </a:ext>
                  </a:extLst>
                </a:gridCol>
                <a:gridCol w="1602157">
                  <a:extLst>
                    <a:ext uri="{9D8B030D-6E8A-4147-A177-3AD203B41FA5}">
                      <a16:colId xmlns:a16="http://schemas.microsoft.com/office/drawing/2014/main" val="2744235731"/>
                    </a:ext>
                  </a:extLst>
                </a:gridCol>
                <a:gridCol w="456456">
                  <a:extLst>
                    <a:ext uri="{9D8B030D-6E8A-4147-A177-3AD203B41FA5}">
                      <a16:colId xmlns:a16="http://schemas.microsoft.com/office/drawing/2014/main" val="558148817"/>
                    </a:ext>
                  </a:extLst>
                </a:gridCol>
                <a:gridCol w="456456">
                  <a:extLst>
                    <a:ext uri="{9D8B030D-6E8A-4147-A177-3AD203B41FA5}">
                      <a16:colId xmlns:a16="http://schemas.microsoft.com/office/drawing/2014/main" val="3438712807"/>
                    </a:ext>
                  </a:extLst>
                </a:gridCol>
                <a:gridCol w="456456">
                  <a:extLst>
                    <a:ext uri="{9D8B030D-6E8A-4147-A177-3AD203B41FA5}">
                      <a16:colId xmlns:a16="http://schemas.microsoft.com/office/drawing/2014/main" val="1370603087"/>
                    </a:ext>
                  </a:extLst>
                </a:gridCol>
                <a:gridCol w="456456">
                  <a:extLst>
                    <a:ext uri="{9D8B030D-6E8A-4147-A177-3AD203B41FA5}">
                      <a16:colId xmlns:a16="http://schemas.microsoft.com/office/drawing/2014/main" val="1158402465"/>
                    </a:ext>
                  </a:extLst>
                </a:gridCol>
                <a:gridCol w="456456">
                  <a:extLst>
                    <a:ext uri="{9D8B030D-6E8A-4147-A177-3AD203B41FA5}">
                      <a16:colId xmlns:a16="http://schemas.microsoft.com/office/drawing/2014/main" val="1421450168"/>
                    </a:ext>
                  </a:extLst>
                </a:gridCol>
                <a:gridCol w="453845">
                  <a:extLst>
                    <a:ext uri="{9D8B030D-6E8A-4147-A177-3AD203B41FA5}">
                      <a16:colId xmlns:a16="http://schemas.microsoft.com/office/drawing/2014/main" val="4218221986"/>
                    </a:ext>
                  </a:extLst>
                </a:gridCol>
              </a:tblGrid>
              <a:tr h="267324"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ID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sequence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#1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#5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#6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#9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#10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904351"/>
                  </a:ext>
                </a:extLst>
              </a:tr>
              <a:tr h="314155">
                <a:tc rowSpan="6"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MSTN</a:t>
                      </a:r>
                      <a:endParaRPr lang="ko-KR" sz="1050" kern="100" dirty="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arget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ACTGTGGATATATC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833778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1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CTGTGGAT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TC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6648783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2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TGTGGAT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1340178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3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TGTGGAT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TCT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9133838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4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ACTGTGG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TC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3628603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5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TGTGGAT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C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3.9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7.3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6.7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6.8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1.4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*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6008996"/>
                  </a:ext>
                </a:extLst>
              </a:tr>
              <a:tr h="314155">
                <a:tc rowSpan="6"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PRNP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arget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AACCAACATGAAGCA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796559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1</a:t>
                      </a:r>
                      <a:endParaRPr lang="ko-KR" sz="1050" kern="100" dirty="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A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AACAT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GCA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129435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2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AACATGAAGCA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9851409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3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AACCAACATGAAGCA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7222711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4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AA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CATGAAGCA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1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402845"/>
                  </a:ext>
                </a:extLst>
              </a:tr>
              <a:tr h="314155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Off-target #5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AACCAACATG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GC</a:t>
                      </a:r>
                      <a:r>
                        <a:rPr lang="en-US" sz="800" kern="1200">
                          <a:solidFill>
                            <a:srgbClr val="FF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</a:t>
                      </a:r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G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0.0%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-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9386863"/>
                  </a:ext>
                </a:extLst>
              </a:tr>
              <a:tr h="314155"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b="1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BLG</a:t>
                      </a:r>
                      <a:r>
                        <a:rPr lang="en-US" sz="800" b="1" kern="1200" baseline="300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**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latinLnBrk="1"/>
                      <a:r>
                        <a:rPr lang="en-US" sz="800" kern="12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arget</a:t>
                      </a:r>
                      <a:endParaRPr lang="ko-KR" sz="1050" kern="10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/>
                      <a:r>
                        <a:rPr lang="en-US" sz="800" kern="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GCGGTGTTCAAGATCGATGG</a:t>
                      </a:r>
                      <a:endParaRPr lang="ko-KR" sz="1050" kern="100" dirty="0">
                        <a:effectLst/>
                        <a:latin typeface="Tahoma" panose="020B0604030504040204" pitchFamily="34" charset="0"/>
                        <a:ea typeface="맑은 고딕" panose="020B0503020000020004" pitchFamily="50" charset="-127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just"/>
                      <a:endParaRPr lang="ko-KR" sz="1050" kern="10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/>
                      <a:endParaRPr lang="ko-KR" sz="1050" kern="100" dirty="0">
                        <a:effectLst/>
                        <a:latin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75124" marR="75124" marT="75124" marB="75124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800624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2E2F36EA-C4BD-0436-91BF-C1595A52AC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7238" y="5197103"/>
            <a:ext cx="5897074" cy="10482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5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upplementary Table 3. Off-target effect detection for gene edited calves</a:t>
            </a:r>
            <a:endParaRPr lang="en-US" altLang="ko-KR" sz="4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* Same SNP were identified, compared to wildtype controls. </a:t>
            </a: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8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** no mismatch sites identified for BLG target site. For each target gene, sites similar with guide RNA sequences on bovine genome (ARS UCD1.2) with sequences, containing mismatches of 2 or 3 were selected possible off-target genes. Five candidate genes for each target gene were analyzed for off-target effect. Red letters = mismatches</a:t>
            </a:r>
            <a:endParaRPr lang="en-US" altLang="ko-KR" sz="105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5941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25</Words>
  <Application>Microsoft Office PowerPoint</Application>
  <PresentationFormat>화면 슬라이드 쇼(4:3)</PresentationFormat>
  <Paragraphs>9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엄 경현</dc:creator>
  <cp:lastModifiedBy>엄 경현</cp:lastModifiedBy>
  <cp:revision>1</cp:revision>
  <dcterms:created xsi:type="dcterms:W3CDTF">2023-04-14T10:57:25Z</dcterms:created>
  <dcterms:modified xsi:type="dcterms:W3CDTF">2023-05-17T23:58:27Z</dcterms:modified>
</cp:coreProperties>
</file>